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9" y="8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662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32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509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122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524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55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072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290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154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521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698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9099C-F3FF-41A2-BA7A-61F8AD0CEA2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57753D-BDF9-4ECE-B062-A9199DD87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573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7280" y="603954"/>
            <a:ext cx="9395959" cy="5453901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705852" y="605785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1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 for deprotected chloroquinolines against sensitive strain K1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3395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7:27Z</dcterms:created>
  <dcterms:modified xsi:type="dcterms:W3CDTF">2020-08-04T16:32:47Z</dcterms:modified>
</cp:coreProperties>
</file>